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91" autoAdjust="0"/>
    <p:restoredTop sz="94660"/>
  </p:normalViewPr>
  <p:slideViewPr>
    <p:cSldViewPr snapToGrid="0">
      <p:cViewPr varScale="1">
        <p:scale>
          <a:sx n="132" d="100"/>
          <a:sy n="132" d="100"/>
        </p:scale>
        <p:origin x="156" y="8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A83B6-083E-065C-107A-B535518290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20DE35-91D6-B6F3-F644-C77AF95F6E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C2F504-7B53-CEB0-CA0D-813C58CEA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4AD0F2-1CD1-25C5-C2D8-26ACD3D5E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A84C90-524D-EEAE-9745-E3FB95E60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420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251C3-DDB1-C2EF-29FA-86F28C91FB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5D2973-F08F-6A4D-13DB-F383C6E54C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E3AE60-C4C3-22DF-CC42-0F574E813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5F72A5-D3E8-3C83-2B72-6EAA35839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770779-8E18-BE6E-78EA-4B8F29091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618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CB3F7D-4250-4A77-A804-107803721F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6B10A8-0FCF-11BB-0075-6F512CF865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AD3691-6025-1A7D-F90C-46FA86753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FFD83-7CE9-467A-C909-5324F367F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732208-47FB-45B1-184C-3469F6CD8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451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8F054-09FF-FBD7-D889-E23A636829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226CBC-CABD-EB27-12C8-B8706FBDFF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A79279-1AE0-A894-F7ED-BEA88DC0F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A017E4-3D2C-F124-3635-AF65728EE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411494-7852-840A-D70B-42B6F5977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52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AD39F1-C6AA-BD71-EC8D-F5D31FB333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C8CA57-24BD-A497-CEC1-162CE96A94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887018-A383-C506-07E0-489F42BE0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520CB9-A8E6-8B60-E317-ACB679753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11C407-5C88-E070-9027-6D4D78573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649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1E2C0E-5BFE-B1A2-7A4D-7A074BAB22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888033-4C6C-F8BA-E36C-2C5E210CD3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CCD27B-F5DD-7732-FC88-57F11B3845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53EA29-1C67-85C0-66DA-2002A55AD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287CEB-2A65-DED6-3D19-8C0957573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FBE716-19C7-74BE-81F0-C9A61FEB1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162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A71D7-ABEB-A545-A283-8DD8271D4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AA7FEB-B295-B313-B3C0-C34CE7A283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8BC3D5-6763-9851-F486-E96AD9B274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05A0BA-3990-BF92-B409-833A8D9EEA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0E68AE-C11A-47D1-541C-0E6A740690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E497DB-60F8-8536-E6BA-C1AF06C6A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424AAB7-835B-ADB2-1B04-28D0F55F0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CC5BA0-2EB8-00AB-1259-5A527C17F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745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A4B51-2AC0-A836-4470-937C595607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94C62F-FEFF-10E5-8045-335E40FA9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320175-7F11-2FB7-A9AB-E0B49A64C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064D29-AAC2-4346-0AED-1338677B3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141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FFD398-62FB-EC93-A2A4-A849B7A67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F68241-E78B-2853-EBC3-05A0B59DC3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58E42E-1D34-B086-5283-D716F3395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924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4E714-659D-628A-D264-7F2968F813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5477A6-9416-41FC-29AD-F26534E3FC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3C67BB-5CBA-D937-5C5C-B55BA868B6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DAD277-5926-1B90-7658-A6D2BF683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833919-30FF-55AC-0B49-DCC44FBFA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458F0E-E66A-D34B-245E-102272141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448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5C5018-5BB5-536E-B0C4-612E018975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186F04-7752-6760-3B39-C0D9B257EA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ADCDAB-1479-706C-8E9C-A784BC06EC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ACCFD1-D925-CC0D-14F7-D9CDF8513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A2BEE1-E4BF-9183-6FD0-295A321EB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04A72F-7474-CFB4-FF54-8DDD381C4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245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A9C3F6-E7EE-FC21-A66F-6605CD8592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6AF019-3C79-C179-2D15-5DEEDD5772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826153-0B2E-7C87-2877-B2190CDE8F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EE42A9-2B1C-1ACB-9543-E1003E8FE1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92D0AA-8888-FEF1-2CB1-445AAB3A25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713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E175F5F-AF1E-B2A0-D75A-E28BC1A544C0}"/>
              </a:ext>
            </a:extLst>
          </p:cNvPr>
          <p:cNvSpPr txBox="1"/>
          <p:nvPr/>
        </p:nvSpPr>
        <p:spPr>
          <a:xfrm>
            <a:off x="267939" y="311736"/>
            <a:ext cx="10355452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 S2:</a:t>
            </a: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lt"/>
                <a:cs typeface="+mn-lt"/>
              </a:rPr>
              <a:t> UMAP visualizations of cell-type clusters from the human aortic valve dataset after batch </a:t>
            </a: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lt"/>
                <a:cs typeface="+mn-lt"/>
              </a:rPr>
              <a:t>correction and integration with </a:t>
            </a:r>
            <a:r>
              <a:rPr kumimoji="0" lang="en-US" sz="18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lt"/>
                <a:cs typeface="+mn-lt"/>
              </a:rPr>
              <a:t>ComBat</a:t>
            </a: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 and SCEMENT.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BEB7858-C308-FAB7-C95B-7BF0C50ABA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260" y="1520348"/>
            <a:ext cx="11722274" cy="49513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133058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24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uru, Srinivas</dc:creator>
  <cp:lastModifiedBy>Aluru, Srinivas</cp:lastModifiedBy>
  <cp:revision>8</cp:revision>
  <dcterms:created xsi:type="dcterms:W3CDTF">2024-11-07T18:07:59Z</dcterms:created>
  <dcterms:modified xsi:type="dcterms:W3CDTF">2024-11-07T18:32:19Z</dcterms:modified>
</cp:coreProperties>
</file>